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4C3E9-7BF0-417D-B4E8-94ABA12490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8B6F8-60AD-4008-98B3-3B1F98559E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715E9-EA8F-482B-9D3F-9F841C930E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89B39-818A-4F59-A1D6-020BD7E5CE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7F302-0B04-4D58-AE31-07428E0412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EF2E2-2A39-4A06-9752-F28EE6C9BB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D638C-7BBA-428A-A87D-38AE5203AC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544B7-AEA1-4733-AE74-B580DA768F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5FE1B-A70A-49FA-8989-F7BA17FB22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DF225-73FF-4789-A23A-4F2BF12A77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2255B-D95F-4B53-8D86-60E3D7BA68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E12E7-3298-4359-B35B-E796A61F9A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BC2E1D-E800-46BD-9ED3-58A75735A52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7"/>
          <p:cNvSpPr/>
          <p:nvPr/>
        </p:nvSpPr>
        <p:spPr>
          <a:xfrm>
            <a:off x="1042920" y="1320840"/>
            <a:ext cx="6048360" cy="5806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Times New Roman"/>
              </a:rPr>
              <a:t>From 301 clinics, 510,182 patients with type 2 diabetes selected at the first eGFR evaluation in datab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20"/>
          <p:cNvSpPr/>
          <p:nvPr/>
        </p:nvSpPr>
        <p:spPr>
          <a:xfrm>
            <a:off x="2000160" y="3833640"/>
            <a:ext cx="5072040" cy="3373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366,955 from 267 clinics constitute the study populatio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1494000" y="2328840"/>
            <a:ext cx="5586120" cy="10674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Times New Roman"/>
              </a:rPr>
              <a:t>Patients excluded according to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Times New Roman"/>
              </a:rPr>
              <a:t>-141,838 treated with insulin at baseli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Times New Roman"/>
              </a:rPr>
              <a:t>-39 patients aged &lt;18 yea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Times New Roman"/>
              </a:rPr>
              <a:t>-1,350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rom clinics with less than 100 patien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287360" y="1916280"/>
            <a:ext cx="209520" cy="617400"/>
          </a:xfrm>
          <a:custGeom>
            <a:avLst/>
            <a:gdLst/>
            <a:ahLst/>
            <a:rect l="l" t="t" r="r" b="b"/>
            <a:pathLst>
              <a:path w="132" h="389">
                <a:moveTo>
                  <a:pt x="4" y="0"/>
                </a:moveTo>
                <a:lnTo>
                  <a:pt x="0" y="389"/>
                </a:lnTo>
                <a:lnTo>
                  <a:pt x="132" y="383"/>
                </a:lnTo>
              </a:path>
            </a:pathLst>
          </a:custGeom>
          <a:noFill/>
          <a:ln w="381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62200" y="3417840"/>
            <a:ext cx="209520" cy="617760"/>
          </a:xfrm>
          <a:custGeom>
            <a:avLst/>
            <a:gdLst/>
            <a:ahLst/>
            <a:rect l="l" t="t" r="r" b="b"/>
            <a:pathLst>
              <a:path w="132" h="389">
                <a:moveTo>
                  <a:pt x="4" y="0"/>
                </a:moveTo>
                <a:lnTo>
                  <a:pt x="0" y="389"/>
                </a:lnTo>
                <a:lnTo>
                  <a:pt x="132" y="383"/>
                </a:lnTo>
              </a:path>
            </a:pathLst>
          </a:custGeom>
          <a:noFill/>
          <a:ln w="381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15T14:08:42Z</dcterms:created>
  <dc:creator>Francesca Viazzi</dc:creator>
  <dc:description/>
  <dc:language>en-US</dc:language>
  <cp:lastModifiedBy>*****</cp:lastModifiedBy>
  <dcterms:modified xsi:type="dcterms:W3CDTF">2017-02-27T12:35:58Z</dcterms:modified>
  <cp:revision>61</cp:revision>
  <dc:subject/>
  <dc:title>Presentazione standard di PowerPoint</dc:title>
</cp:coreProperties>
</file>